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3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4840B96-9F14-5C43-8868-8B5E0808B709}"/>
              </a:ext>
            </a:extLst>
          </p:cNvPr>
          <p:cNvSpPr txBox="1"/>
          <p:nvPr/>
        </p:nvSpPr>
        <p:spPr>
          <a:xfrm>
            <a:off x="187421" y="5566742"/>
            <a:ext cx="876915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. S2. 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Video of a marmoset jumping and tracking when it is moving quickly. 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 of marmosets detected using Lidar. White point: centroid of marmosets, white box: virtual space of the cage. (c) Location of marmosets on video frame detected using Yolo, box: detected marmosets. (d) 3D coordinate of marmosets calculated using video tracking, colored point: coordinate of marmoset. (e, f) Individual information added to C and D using face identification</a:t>
            </a:r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reen: I5072M, red: I5894F, yellow: I940M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2">
            <a:hlinkClick r:id="" action="ppaction://media"/>
            <a:extLst>
              <a:ext uri="{FF2B5EF4-FFF2-40B4-BE49-F238E27FC236}">
                <a16:creationId xmlns:a16="http://schemas.microsoft.com/office/drawing/2014/main" id="{2AF5BB6B-C783-74D4-77CF-BAF41044CC1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92866" y="0"/>
            <a:ext cx="6999398" cy="5249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032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1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7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3</cp:revision>
  <dcterms:created xsi:type="dcterms:W3CDTF">2023-07-18T01:28:01Z</dcterms:created>
  <dcterms:modified xsi:type="dcterms:W3CDTF">2023-12-05T08:05:45Z</dcterms:modified>
</cp:coreProperties>
</file>